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gif" ContentType="image/gi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 snapToGrid="0" snapToObjects="1" showGuides="1">
      <p:cViewPr varScale="1">
        <p:scale>
          <a:sx n="88" d="100"/>
          <a:sy n="88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658A2-ACBA-504E-A01C-0B20CAF2ADDB}" type="datetimeFigureOut">
              <a:rPr lang="en-US" smtClean="0"/>
              <a:pPr/>
              <a:t>3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90C73-747B-C843-AA38-2431760EA4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442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658A2-ACBA-504E-A01C-0B20CAF2ADDB}" type="datetimeFigureOut">
              <a:rPr lang="en-US" smtClean="0"/>
              <a:pPr/>
              <a:t>3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90C73-747B-C843-AA38-2431760EA4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94980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658A2-ACBA-504E-A01C-0B20CAF2ADDB}" type="datetimeFigureOut">
              <a:rPr lang="en-US" smtClean="0"/>
              <a:pPr/>
              <a:t>3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90C73-747B-C843-AA38-2431760EA4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41633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658A2-ACBA-504E-A01C-0B20CAF2ADDB}" type="datetimeFigureOut">
              <a:rPr lang="en-US" smtClean="0"/>
              <a:pPr/>
              <a:t>3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90C73-747B-C843-AA38-2431760EA4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51015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658A2-ACBA-504E-A01C-0B20CAF2ADDB}" type="datetimeFigureOut">
              <a:rPr lang="en-US" smtClean="0"/>
              <a:pPr/>
              <a:t>3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90C73-747B-C843-AA38-2431760EA4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35299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658A2-ACBA-504E-A01C-0B20CAF2ADDB}" type="datetimeFigureOut">
              <a:rPr lang="en-US" smtClean="0"/>
              <a:pPr/>
              <a:t>3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90C73-747B-C843-AA38-2431760EA4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53649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658A2-ACBA-504E-A01C-0B20CAF2ADDB}" type="datetimeFigureOut">
              <a:rPr lang="en-US" smtClean="0"/>
              <a:pPr/>
              <a:t>3/28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90C73-747B-C843-AA38-2431760EA4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67949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658A2-ACBA-504E-A01C-0B20CAF2ADDB}" type="datetimeFigureOut">
              <a:rPr lang="en-US" smtClean="0"/>
              <a:pPr/>
              <a:t>3/28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90C73-747B-C843-AA38-2431760EA4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46291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658A2-ACBA-504E-A01C-0B20CAF2ADDB}" type="datetimeFigureOut">
              <a:rPr lang="en-US" smtClean="0"/>
              <a:pPr/>
              <a:t>3/28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90C73-747B-C843-AA38-2431760EA4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97514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658A2-ACBA-504E-A01C-0B20CAF2ADDB}" type="datetimeFigureOut">
              <a:rPr lang="en-US" smtClean="0"/>
              <a:pPr/>
              <a:t>3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90C73-747B-C843-AA38-2431760EA4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84702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658A2-ACBA-504E-A01C-0B20CAF2ADDB}" type="datetimeFigureOut">
              <a:rPr lang="en-US" smtClean="0"/>
              <a:pPr/>
              <a:t>3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90C73-747B-C843-AA38-2431760EA4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27951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E658A2-ACBA-504E-A01C-0B20CAF2ADDB}" type="datetimeFigureOut">
              <a:rPr lang="en-US" smtClean="0"/>
              <a:pPr/>
              <a:t>3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90C73-747B-C843-AA38-2431760EA4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6681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1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667000" y="2280214"/>
            <a:ext cx="3810000" cy="24003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951623" y="836023"/>
            <a:ext cx="73575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Video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1. 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Gif animation. Single jet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electrospun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from cellulose based system </a:t>
            </a:r>
          </a:p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isotropic solution. 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2429688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02130" y="1273348"/>
            <a:ext cx="7437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Video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2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Gif animation. Rotating single jet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electrospun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from cellulose based system liquid crystal solution. 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 descr="S2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667000" y="2773539"/>
            <a:ext cx="3810000" cy="2400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9137553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CCE8C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4</Words>
  <Application>Microsoft Office PowerPoint</Application>
  <PresentationFormat>On-screen Show (4:3)</PresentationFormat>
  <Paragraphs>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Helena Godinho</dc:creator>
  <cp:lastModifiedBy>mdpi_beijing</cp:lastModifiedBy>
  <cp:revision>4</cp:revision>
  <dcterms:created xsi:type="dcterms:W3CDTF">2013-01-31T19:16:28Z</dcterms:created>
  <dcterms:modified xsi:type="dcterms:W3CDTF">2013-03-28T06:19:25Z</dcterms:modified>
</cp:coreProperties>
</file>